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405"/>
  </p:normalViewPr>
  <p:slideViewPr>
    <p:cSldViewPr snapToGrid="0" snapToObjects="1">
      <p:cViewPr varScale="1">
        <p:scale>
          <a:sx n="131" d="100"/>
          <a:sy n="131" d="100"/>
        </p:scale>
        <p:origin x="162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926DF-7744-0F4A-B7A7-AE225BCA5638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5D115-BB04-E841-9661-9257BC8F02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7454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926DF-7744-0F4A-B7A7-AE225BCA5638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5D115-BB04-E841-9661-9257BC8F02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0303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926DF-7744-0F4A-B7A7-AE225BCA5638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5D115-BB04-E841-9661-9257BC8F02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909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926DF-7744-0F4A-B7A7-AE225BCA5638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5D115-BB04-E841-9661-9257BC8F02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1988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926DF-7744-0F4A-B7A7-AE225BCA5638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5D115-BB04-E841-9661-9257BC8F02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64311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926DF-7744-0F4A-B7A7-AE225BCA5638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5D115-BB04-E841-9661-9257BC8F02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0164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926DF-7744-0F4A-B7A7-AE225BCA5638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5D115-BB04-E841-9661-9257BC8F02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3157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926DF-7744-0F4A-B7A7-AE225BCA5638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5D115-BB04-E841-9661-9257BC8F02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077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926DF-7744-0F4A-B7A7-AE225BCA5638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5D115-BB04-E841-9661-9257BC8F02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2527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926DF-7744-0F4A-B7A7-AE225BCA5638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5D115-BB04-E841-9661-9257BC8F02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7410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926DF-7744-0F4A-B7A7-AE225BCA5638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5D115-BB04-E841-9661-9257BC8F02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8774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F926DF-7744-0F4A-B7A7-AE225BCA5638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35D115-BB04-E841-9661-9257BC8F02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0056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2">
            <a:extLst>
              <a:ext uri="{FF2B5EF4-FFF2-40B4-BE49-F238E27FC236}">
                <a16:creationId xmlns:a16="http://schemas.microsoft.com/office/drawing/2014/main" id="{EFF7C54D-3984-4C4F-B165-F1E2E8EF4161}"/>
              </a:ext>
            </a:extLst>
          </p:cNvPr>
          <p:cNvGraphicFramePr>
            <a:graphicFrameLocks noGrp="1"/>
          </p:cNvGraphicFramePr>
          <p:nvPr/>
        </p:nvGraphicFramePr>
        <p:xfrm>
          <a:off x="1012757" y="1661159"/>
          <a:ext cx="6861243" cy="371856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287081">
                  <a:extLst>
                    <a:ext uri="{9D8B030D-6E8A-4147-A177-3AD203B41FA5}">
                      <a16:colId xmlns:a16="http://schemas.microsoft.com/office/drawing/2014/main" val="2543387666"/>
                    </a:ext>
                  </a:extLst>
                </a:gridCol>
                <a:gridCol w="2287081">
                  <a:extLst>
                    <a:ext uri="{9D8B030D-6E8A-4147-A177-3AD203B41FA5}">
                      <a16:colId xmlns:a16="http://schemas.microsoft.com/office/drawing/2014/main" val="933016819"/>
                    </a:ext>
                  </a:extLst>
                </a:gridCol>
                <a:gridCol w="2287081">
                  <a:extLst>
                    <a:ext uri="{9D8B030D-6E8A-4147-A177-3AD203B41FA5}">
                      <a16:colId xmlns:a16="http://schemas.microsoft.com/office/drawing/2014/main" val="1266039189"/>
                    </a:ext>
                  </a:extLst>
                </a:gridCol>
              </a:tblGrid>
              <a:tr h="357992">
                <a:tc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Ulcerative Colitis </a:t>
                      </a:r>
                      <a:endParaRPr kumimoji="1" lang="ja-JP" altLang="en-US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 Crohn’s Disease</a:t>
                      </a:r>
                      <a:endParaRPr kumimoji="1" lang="ja-JP" altLang="en-US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720050483"/>
                  </a:ext>
                </a:extLst>
              </a:tr>
              <a:tr h="73152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kumimoji="1" lang="en-US" altLang="ja-JP" sz="1400" b="1" dirty="0"/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400" b="1" dirty="0"/>
                        <a:t>Number of Patients</a:t>
                      </a:r>
                      <a:endParaRPr kumimoji="1" lang="ja-JP" altLang="en-US" sz="1400" b="1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kumimoji="1" lang="en-US" altLang="ja-JP" sz="1400" dirty="0">
                        <a:solidFill>
                          <a:schemeClr val="tx1"/>
                        </a:solidFill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104</a:t>
                      </a:r>
                      <a:endParaRPr kumimoji="1" lang="ja-JP" altLang="en-US" sz="140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kumimoji="1" lang="en-US" altLang="ja-JP" sz="1400" dirty="0">
                        <a:solidFill>
                          <a:schemeClr val="tx1"/>
                        </a:solidFill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74</a:t>
                      </a:r>
                      <a:endParaRPr kumimoji="1" lang="ja-JP" altLang="en-US" sz="140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7456629"/>
                  </a:ext>
                </a:extLst>
              </a:tr>
              <a:tr h="73152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kern="100" dirty="0">
                          <a:effectLst/>
                        </a:rPr>
                        <a:t>Ratio of anti-TNFα antibodies user at diagnosis of COVID-19 (%)</a:t>
                      </a:r>
                      <a:endParaRPr lang="ja-JP" altLang="ja-JP" sz="14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kumimoji="1" lang="en-US" altLang="ja-JP" sz="1400" dirty="0">
                        <a:solidFill>
                          <a:schemeClr val="tx1"/>
                        </a:solidFill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18.2% (19/104)</a:t>
                      </a:r>
                      <a:endParaRPr kumimoji="1" lang="ja-JP" altLang="en-US" sz="140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kumimoji="1" lang="en-US" altLang="ja-JP" sz="1400" dirty="0">
                        <a:solidFill>
                          <a:schemeClr val="tx1"/>
                        </a:solidFill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70.3% (52/74)</a:t>
                      </a:r>
                      <a:endParaRPr kumimoji="1" lang="ja-JP" altLang="en-US" sz="140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54655634"/>
                  </a:ext>
                </a:extLst>
              </a:tr>
              <a:tr h="73152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kumimoji="1" lang="en-US" altLang="ja-JP" sz="1400" b="1" dirty="0"/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400" b="1" dirty="0"/>
                        <a:t>Continuation of 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ja-JP" sz="1400" b="1" kern="100" dirty="0">
                          <a:effectLst/>
                        </a:rPr>
                        <a:t>anti-TNFα antibodies during COVID-19 (%)</a:t>
                      </a:r>
                      <a:endParaRPr kumimoji="1" lang="ja-JP" altLang="en-US" sz="1400" b="1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kumimoji="1" lang="en-US" altLang="ja-JP" sz="1400" dirty="0"/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400" dirty="0"/>
                        <a:t>57.9% (11/19)</a:t>
                      </a:r>
                      <a:endParaRPr kumimoji="1" lang="ja-JP" altLang="en-US" sz="14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kumimoji="1" lang="en-US" altLang="ja-JP" sz="1400" dirty="0"/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400" dirty="0"/>
                        <a:t>71.2% (37/52)</a:t>
                      </a:r>
                      <a:endParaRPr kumimoji="1" lang="ja-JP" altLang="en-US" sz="14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982293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kumimoji="1" lang="en-US" altLang="ja-JP" sz="1400" b="1" dirty="0"/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400" b="1" dirty="0"/>
                        <a:t>Discontinuation of 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ja-JP" sz="1400" b="1" kern="100" dirty="0">
                          <a:effectLst/>
                        </a:rPr>
                        <a:t>anti-TNFα antibodies during COVID-19 (%)</a:t>
                      </a:r>
                      <a:endParaRPr kumimoji="1" lang="ja-JP" altLang="en-US" sz="1400" b="1"/>
                    </a:p>
                  </a:txBody>
                  <a:tcPr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kumimoji="1" lang="en-US" altLang="ja-JP" sz="1400" dirty="0"/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400" dirty="0"/>
                        <a:t>42.1% (8/19)</a:t>
                      </a:r>
                      <a:endParaRPr kumimoji="1" lang="ja-JP" altLang="en-US" sz="1400"/>
                    </a:p>
                  </a:txBody>
                  <a:tcPr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kumimoji="1" lang="en-US" altLang="ja-JP" sz="1400" dirty="0"/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400" dirty="0"/>
                        <a:t>28.8%(15/52)</a:t>
                      </a:r>
                      <a:endParaRPr kumimoji="1" lang="ja-JP" altLang="en-US" sz="1400"/>
                    </a:p>
                  </a:txBody>
                  <a:tcPr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7083268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E92B29A-850A-CC46-B4B6-3E8E5A24DEBC}"/>
              </a:ext>
            </a:extLst>
          </p:cNvPr>
          <p:cNvSpPr txBox="1"/>
          <p:nvPr/>
        </p:nvSpPr>
        <p:spPr>
          <a:xfrm>
            <a:off x="799397" y="831950"/>
            <a:ext cx="780797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 Table 1.  </a:t>
            </a:r>
          </a:p>
          <a:p>
            <a:r>
              <a:rPr kumimoji="1" lang="en-US" altLang="ja-JP" b="1" dirty="0"/>
              <a:t>The usage of </a:t>
            </a:r>
            <a:r>
              <a:rPr lang="en-US" altLang="ja-JP" b="1" kern="100" dirty="0"/>
              <a:t>anti-TNFα antibodies in patients with UC and CD during COVID-19 </a:t>
            </a:r>
            <a:r>
              <a:rPr kumimoji="1" lang="en-US" altLang="ja-JP" b="1" dirty="0"/>
              <a:t> </a:t>
            </a:r>
            <a:endParaRPr kumimoji="1" lang="ja-JP" altLang="en-US" b="1"/>
          </a:p>
        </p:txBody>
      </p:sp>
    </p:spTree>
    <p:extLst>
      <p:ext uri="{BB962C8B-B14F-4D97-AF65-F5344CB8AC3E}">
        <p14:creationId xmlns:p14="http://schemas.microsoft.com/office/powerpoint/2010/main" val="2016234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0</Words>
  <Application>Microsoft Macintosh PowerPoint</Application>
  <PresentationFormat>画面に合わせる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明朝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仲瀬 裕志</dc:creator>
  <cp:lastModifiedBy>仲瀬 裕志</cp:lastModifiedBy>
  <cp:revision>2</cp:revision>
  <dcterms:created xsi:type="dcterms:W3CDTF">2022-01-05T08:21:54Z</dcterms:created>
  <dcterms:modified xsi:type="dcterms:W3CDTF">2022-01-05T08:22:40Z</dcterms:modified>
</cp:coreProperties>
</file>